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1" d="100"/>
          <a:sy n="61" d="100"/>
        </p:scale>
        <p:origin x="7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A46569-1400-2E26-0E61-FA393A2564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7C9B8BE-74FD-7243-E826-5E8E6B8F7B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14C1CE-C457-7E75-B5E8-5F1F80DC5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38CA9F-7F0F-1B70-FADA-4D7EC5FC2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448558-2567-F229-EBEF-701A06E65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83762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EC20E2-54B1-1B7C-C117-CDC728E8F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D7C2F1B-8D82-3936-2D54-3CDB912A8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CE467B-B83A-FF9A-844F-91D278F09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BF74AE-920F-2518-232E-AC31B6FB4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C61A7C-FAAB-071E-FDB1-5DA598875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58057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532ACA-E300-CE88-F430-1EF5E2F990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AD55AA-6C1C-CF51-3F4E-C3D415F6C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0ACE78-A847-E30F-2882-8A13E6ECA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E5EFAC-B76C-9E96-8000-98A21985F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596C2E-1FBE-160B-DEC2-FF46A48BA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150900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02826B-32E5-4638-A4A6-9771FE5B8C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757C35-FAB1-D9A5-6514-CC1CEFBF23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255D74-352A-B457-B50E-59D3B2E0C0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C67170-AC3C-652F-C408-5584824FD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807C79-2B5C-559F-FCC3-C5CF4E54D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3585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D1DA09-E8EF-FC47-589A-59F7693D5E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3A2658-8670-A0D4-7789-3B14E05CBD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CD16D6-D244-5969-D1FD-C69B35B55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C1958F-0BA5-4856-A52A-3EFE41C2A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B9D7A5-5456-99B3-9494-CD3043DB9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27936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9153A-0D47-234F-67D9-4B7F37499C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4FD46F-3399-65CB-81FD-CB201517CD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E631A2-0095-D06B-D300-7C5B32DEF9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13B8EE-9752-6A5A-9B7E-A7148E56D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CFC928-1DD0-909F-7BDF-F620410E69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898F37-E7D0-0EF8-1028-3594286082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84366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BF430-A6CF-DEA7-81FE-312E3E83E6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B1E874-5271-EA1A-355C-B1F5188BC8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F3854F-912F-4097-E394-29ACCDAF50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7F6C4D-21BB-4E84-0E4D-EC351CDAC0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35E541-1336-894B-82DB-542A48E556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DFFC4F-EA73-9719-D815-3E4F618FD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3AE6F6-EC74-FDB2-9E4F-790DA088A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09B2C6-BF01-96DB-B6D5-EA9EAA8D3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01932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008118-9BC5-D5AD-CD8D-22CCED96A7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A8B6CD2-FE8E-3A9B-5A82-7D0A6D4F9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0F13A7A-5969-2A47-7725-77993A86C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6FD506-9E8C-AD6A-8E0D-C6C8B7E1E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29668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9FA093-4445-3565-79E3-EB65D6618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CE8ED43-D540-741F-453D-5BF851C25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19B6CE-13AC-BB18-51B3-CF18654ED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8541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9998FD-914E-9909-5300-3DBD9D8B47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97B5EC-A380-7C64-A331-83AC217B32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904740-48DD-F015-E397-8F30BF64C6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CAAAFB-A74F-84AC-DC7D-1BEC285A6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E8EB48-96BF-44AB-FA79-05C8965C0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7E8CA4-F193-5B50-81CD-1091C55DF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709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C2873-F3B3-2FC7-BC27-6972D22EE7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2F8948-CB70-219E-AE61-2E429BB902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167249-D4EA-7F8F-ECCA-AA513038D0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5B8A1D-0DC2-0875-49E4-E3F502D64B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3C0391-0F2C-9DEF-1294-24E014762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256F10-9242-DF93-2AFA-6E62935C4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0967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2ECC5F4-6F90-8706-CC60-2BA2682B07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D010A0-6E5A-C317-458E-9D04CB702E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69CAD3-4030-FA4B-E988-750458BBF7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46C2D7-7AAE-4CEF-9493-B3F40CFEA8CA}" type="datetimeFigureOut">
              <a:rPr lang="en-AU" smtClean="0"/>
              <a:t>1/04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BC1D3F-FB3D-1B11-6C2D-FE14D2AB68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4B28E8-0F74-A38A-0213-A57F749BF6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9D962-393F-4C4F-A1B0-E65AFC51F028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10989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5AD70DC2-32D1-25EE-6001-F765D17BAAAA}"/>
              </a:ext>
            </a:extLst>
          </p:cNvPr>
          <p:cNvGrpSpPr/>
          <p:nvPr/>
        </p:nvGrpSpPr>
        <p:grpSpPr>
          <a:xfrm>
            <a:off x="1266825" y="838200"/>
            <a:ext cx="2009775" cy="666750"/>
            <a:chOff x="1266825" y="838200"/>
            <a:chExt cx="2009775" cy="666750"/>
          </a:xfrm>
        </p:grpSpPr>
        <p:sp>
          <p:nvSpPr>
            <p:cNvPr id="4" name="Rectangle: Rounded Corners 3">
              <a:extLst>
                <a:ext uri="{FF2B5EF4-FFF2-40B4-BE49-F238E27FC236}">
                  <a16:creationId xmlns:a16="http://schemas.microsoft.com/office/drawing/2014/main" id="{C66D865C-9F88-E034-D2C1-BDE4A28F59E5}"/>
                </a:ext>
              </a:extLst>
            </p:cNvPr>
            <p:cNvSpPr/>
            <p:nvPr/>
          </p:nvSpPr>
          <p:spPr>
            <a:xfrm>
              <a:off x="1266825" y="857250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6CFE689-B8D8-4366-B90B-8DD7F5B2D0C4}"/>
                </a:ext>
              </a:extLst>
            </p:cNvPr>
            <p:cNvSpPr txBox="1"/>
            <p:nvPr/>
          </p:nvSpPr>
          <p:spPr>
            <a:xfrm>
              <a:off x="1409699" y="838200"/>
              <a:ext cx="172402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Wild Einkorn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Triticum </a:t>
              </a:r>
              <a:r>
                <a:rPr lang="en-AU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urartu</a:t>
              </a:r>
              <a:endParaRPr lang="en-AU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7CC20CC-8F1A-E7BD-5E29-0F40F9E7251C}"/>
              </a:ext>
            </a:extLst>
          </p:cNvPr>
          <p:cNvGrpSpPr/>
          <p:nvPr/>
        </p:nvGrpSpPr>
        <p:grpSpPr>
          <a:xfrm>
            <a:off x="3686173" y="857250"/>
            <a:ext cx="2009777" cy="647700"/>
            <a:chOff x="3686173" y="857250"/>
            <a:chExt cx="2009777" cy="647700"/>
          </a:xfrm>
        </p:grpSpPr>
        <p:sp>
          <p:nvSpPr>
            <p:cNvPr id="5" name="Rectangle: Rounded Corners 4">
              <a:extLst>
                <a:ext uri="{FF2B5EF4-FFF2-40B4-BE49-F238E27FC236}">
                  <a16:creationId xmlns:a16="http://schemas.microsoft.com/office/drawing/2014/main" id="{D11430D9-D33D-D80A-7141-B3913439BAD4}"/>
                </a:ext>
              </a:extLst>
            </p:cNvPr>
            <p:cNvSpPr/>
            <p:nvPr/>
          </p:nvSpPr>
          <p:spPr>
            <a:xfrm>
              <a:off x="3686175" y="857250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252ACBF-47B2-C41A-4F6A-84C30D5EB1CA}"/>
                </a:ext>
              </a:extLst>
            </p:cNvPr>
            <p:cNvSpPr txBox="1"/>
            <p:nvPr/>
          </p:nvSpPr>
          <p:spPr>
            <a:xfrm>
              <a:off x="3686173" y="857250"/>
              <a:ext cx="200977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Goat grass 1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Aegilops </a:t>
              </a:r>
              <a:r>
                <a:rPr lang="en-AU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peltoides</a:t>
              </a:r>
              <a:endParaRPr lang="en-AU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77E538BC-B384-3496-B370-2D824B0C1D37}"/>
              </a:ext>
            </a:extLst>
          </p:cNvPr>
          <p:cNvGrpSpPr/>
          <p:nvPr/>
        </p:nvGrpSpPr>
        <p:grpSpPr>
          <a:xfrm>
            <a:off x="2681285" y="1885950"/>
            <a:ext cx="2009776" cy="657225"/>
            <a:chOff x="2681285" y="1885950"/>
            <a:chExt cx="2009776" cy="657225"/>
          </a:xfrm>
        </p:grpSpPr>
        <p:sp>
          <p:nvSpPr>
            <p:cNvPr id="6" name="Rectangle: Rounded Corners 5">
              <a:extLst>
                <a:ext uri="{FF2B5EF4-FFF2-40B4-BE49-F238E27FC236}">
                  <a16:creationId xmlns:a16="http://schemas.microsoft.com/office/drawing/2014/main" id="{BE911651-B6DA-837E-B02C-404C801375C4}"/>
                </a:ext>
              </a:extLst>
            </p:cNvPr>
            <p:cNvSpPr/>
            <p:nvPr/>
          </p:nvSpPr>
          <p:spPr>
            <a:xfrm>
              <a:off x="2681286" y="1895475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0AC78AB-2639-CE52-54E3-9824EBC7FCDB}"/>
                </a:ext>
              </a:extLst>
            </p:cNvPr>
            <p:cNvSpPr txBox="1"/>
            <p:nvPr/>
          </p:nvSpPr>
          <p:spPr>
            <a:xfrm>
              <a:off x="2681285" y="1885950"/>
              <a:ext cx="200977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Wild Emmer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Triticum </a:t>
              </a:r>
              <a:r>
                <a:rPr lang="en-AU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icoccoides</a:t>
              </a:r>
              <a:endParaRPr lang="en-AU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CBFF76F1-5FC7-75E6-41B2-94541927D772}"/>
              </a:ext>
            </a:extLst>
          </p:cNvPr>
          <p:cNvGrpSpPr/>
          <p:nvPr/>
        </p:nvGrpSpPr>
        <p:grpSpPr>
          <a:xfrm>
            <a:off x="5091112" y="1882973"/>
            <a:ext cx="2009775" cy="660202"/>
            <a:chOff x="5091112" y="1882973"/>
            <a:chExt cx="2009775" cy="660202"/>
          </a:xfrm>
        </p:grpSpPr>
        <p:sp>
          <p:nvSpPr>
            <p:cNvPr id="7" name="Rectangle: Rounded Corners 6">
              <a:extLst>
                <a:ext uri="{FF2B5EF4-FFF2-40B4-BE49-F238E27FC236}">
                  <a16:creationId xmlns:a16="http://schemas.microsoft.com/office/drawing/2014/main" id="{C8382F5D-447B-F649-0F38-FB1383B123AC}"/>
                </a:ext>
              </a:extLst>
            </p:cNvPr>
            <p:cNvSpPr/>
            <p:nvPr/>
          </p:nvSpPr>
          <p:spPr>
            <a:xfrm>
              <a:off x="5091112" y="1895475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4AEA0B34-61BA-0104-61CF-FBD6CBDDE375}"/>
                </a:ext>
              </a:extLst>
            </p:cNvPr>
            <p:cNvSpPr txBox="1"/>
            <p:nvPr/>
          </p:nvSpPr>
          <p:spPr>
            <a:xfrm>
              <a:off x="5091112" y="1882973"/>
              <a:ext cx="200977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Goat grass 2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Aegilops </a:t>
              </a:r>
              <a:r>
                <a:rPr lang="en-AU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auschii</a:t>
              </a:r>
              <a:endParaRPr lang="en-AU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id="{290A3CDC-FE84-BBE6-AA96-9A7F2B412623}"/>
              </a:ext>
            </a:extLst>
          </p:cNvPr>
          <p:cNvGrpSpPr/>
          <p:nvPr/>
        </p:nvGrpSpPr>
        <p:grpSpPr>
          <a:xfrm>
            <a:off x="2681285" y="2933700"/>
            <a:ext cx="2009777" cy="647700"/>
            <a:chOff x="2681285" y="2933700"/>
            <a:chExt cx="2009777" cy="647700"/>
          </a:xfrm>
        </p:grpSpPr>
        <p:sp>
          <p:nvSpPr>
            <p:cNvPr id="8" name="Rectangle: Rounded Corners 7">
              <a:extLst>
                <a:ext uri="{FF2B5EF4-FFF2-40B4-BE49-F238E27FC236}">
                  <a16:creationId xmlns:a16="http://schemas.microsoft.com/office/drawing/2014/main" id="{5F1397B3-9988-AFB1-0077-8355FE1DD334}"/>
                </a:ext>
              </a:extLst>
            </p:cNvPr>
            <p:cNvSpPr/>
            <p:nvPr/>
          </p:nvSpPr>
          <p:spPr>
            <a:xfrm>
              <a:off x="2681287" y="2933700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7DE4226-DDEF-6B9D-8428-5BEBC1418744}"/>
                </a:ext>
              </a:extLst>
            </p:cNvPr>
            <p:cNvSpPr txBox="1"/>
            <p:nvPr/>
          </p:nvSpPr>
          <p:spPr>
            <a:xfrm>
              <a:off x="2681285" y="2943225"/>
              <a:ext cx="200977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Cultivated Emmer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Triticum </a:t>
              </a:r>
              <a:r>
                <a:rPr lang="en-AU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icoccum</a:t>
              </a:r>
              <a:endParaRPr lang="en-AU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409AF0E3-599A-52CC-D29A-A0302E3BB79C}"/>
              </a:ext>
            </a:extLst>
          </p:cNvPr>
          <p:cNvGrpSpPr/>
          <p:nvPr/>
        </p:nvGrpSpPr>
        <p:grpSpPr>
          <a:xfrm>
            <a:off x="2666995" y="3971925"/>
            <a:ext cx="2024065" cy="647700"/>
            <a:chOff x="3671883" y="3914775"/>
            <a:chExt cx="2024065" cy="647700"/>
          </a:xfrm>
        </p:grpSpPr>
        <p:sp>
          <p:nvSpPr>
            <p:cNvPr id="9" name="Rectangle: Rounded Corners 8">
              <a:extLst>
                <a:ext uri="{FF2B5EF4-FFF2-40B4-BE49-F238E27FC236}">
                  <a16:creationId xmlns:a16="http://schemas.microsoft.com/office/drawing/2014/main" id="{1ACC7F45-C01C-043A-E52F-8D0872437B0C}"/>
                </a:ext>
              </a:extLst>
            </p:cNvPr>
            <p:cNvSpPr/>
            <p:nvPr/>
          </p:nvSpPr>
          <p:spPr>
            <a:xfrm>
              <a:off x="3686173" y="3914775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BCC7303-D89E-45C3-8CC5-0A0B88D6F9F6}"/>
                </a:ext>
              </a:extLst>
            </p:cNvPr>
            <p:cNvSpPr txBox="1"/>
            <p:nvPr/>
          </p:nvSpPr>
          <p:spPr>
            <a:xfrm>
              <a:off x="3671883" y="3927276"/>
              <a:ext cx="200977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Spelt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Triticum </a:t>
              </a:r>
              <a:r>
                <a:rPr lang="en-AU" sz="16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pelta</a:t>
              </a:r>
              <a:endParaRPr lang="en-AU" sz="16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066F3EBE-6558-165B-9BCA-F4E745C26C72}"/>
              </a:ext>
            </a:extLst>
          </p:cNvPr>
          <p:cNvGrpSpPr/>
          <p:nvPr/>
        </p:nvGrpSpPr>
        <p:grpSpPr>
          <a:xfrm>
            <a:off x="1169194" y="5010150"/>
            <a:ext cx="2107406" cy="647700"/>
            <a:chOff x="1169194" y="5010150"/>
            <a:chExt cx="2107406" cy="647700"/>
          </a:xfrm>
        </p:grpSpPr>
        <p:sp>
          <p:nvSpPr>
            <p:cNvPr id="10" name="Rectangle: Rounded Corners 9">
              <a:extLst>
                <a:ext uri="{FF2B5EF4-FFF2-40B4-BE49-F238E27FC236}">
                  <a16:creationId xmlns:a16="http://schemas.microsoft.com/office/drawing/2014/main" id="{35FBD51B-657F-ACCD-06E1-6398692D1CFD}"/>
                </a:ext>
              </a:extLst>
            </p:cNvPr>
            <p:cNvSpPr/>
            <p:nvPr/>
          </p:nvSpPr>
          <p:spPr>
            <a:xfrm>
              <a:off x="1266825" y="5010150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998E00E-FD03-B191-8644-4DF8468330A9}"/>
                </a:ext>
              </a:extLst>
            </p:cNvPr>
            <p:cNvSpPr txBox="1"/>
            <p:nvPr/>
          </p:nvSpPr>
          <p:spPr>
            <a:xfrm>
              <a:off x="1169194" y="5010150"/>
              <a:ext cx="200977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Durum wheat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Triticum durum</a:t>
              </a:r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1AD6650F-5909-E9AF-79C2-92A9FE1E9908}"/>
              </a:ext>
            </a:extLst>
          </p:cNvPr>
          <p:cNvGrpSpPr/>
          <p:nvPr/>
        </p:nvGrpSpPr>
        <p:grpSpPr>
          <a:xfrm>
            <a:off x="5091112" y="5024438"/>
            <a:ext cx="2040731" cy="647700"/>
            <a:chOff x="5091112" y="5024438"/>
            <a:chExt cx="2040731" cy="647700"/>
          </a:xfrm>
        </p:grpSpPr>
        <p:sp>
          <p:nvSpPr>
            <p:cNvPr id="11" name="Rectangle: Rounded Corners 10">
              <a:extLst>
                <a:ext uri="{FF2B5EF4-FFF2-40B4-BE49-F238E27FC236}">
                  <a16:creationId xmlns:a16="http://schemas.microsoft.com/office/drawing/2014/main" id="{23E11318-59A7-2DD1-3AB4-6D8EA91B25E0}"/>
                </a:ext>
              </a:extLst>
            </p:cNvPr>
            <p:cNvSpPr/>
            <p:nvPr/>
          </p:nvSpPr>
          <p:spPr>
            <a:xfrm>
              <a:off x="5091112" y="5024438"/>
              <a:ext cx="2009775" cy="647700"/>
            </a:xfrm>
            <a:prstGeom prst="roundRect">
              <a:avLst>
                <a:gd name="adj" fmla="val 26079"/>
              </a:avLst>
            </a:prstGeom>
            <a:solidFill>
              <a:schemeClr val="accent1">
                <a:alpha val="1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4A20D23-6A42-16E9-03D9-852DB813E877}"/>
                </a:ext>
              </a:extLst>
            </p:cNvPr>
            <p:cNvSpPr txBox="1"/>
            <p:nvPr/>
          </p:nvSpPr>
          <p:spPr>
            <a:xfrm>
              <a:off x="5122068" y="5042297"/>
              <a:ext cx="2009775" cy="6155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dirty="0">
                  <a:latin typeface="Arial" panose="020B0604020202020204" pitchFamily="34" charset="0"/>
                  <a:cs typeface="Arial" panose="020B0604020202020204" pitchFamily="34" charset="0"/>
                </a:rPr>
                <a:t>Bread wheat</a:t>
              </a:r>
            </a:p>
            <a:p>
              <a:pPr algn="ctr"/>
              <a:r>
                <a:rPr lang="en-AU" sz="1600" i="1" dirty="0">
                  <a:latin typeface="Arial" panose="020B0604020202020204" pitchFamily="34" charset="0"/>
                  <a:cs typeface="Arial" panose="020B0604020202020204" pitchFamily="34" charset="0"/>
                </a:rPr>
                <a:t>Triticum aestivum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191521A-FA1B-6DFE-71F2-CB6664AEAD77}"/>
              </a:ext>
            </a:extLst>
          </p:cNvPr>
          <p:cNvSpPr txBox="1"/>
          <p:nvPr/>
        </p:nvSpPr>
        <p:spPr>
          <a:xfrm rot="16200000">
            <a:off x="667976" y="5081596"/>
            <a:ext cx="844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AAB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D4F8106-A020-35A0-BAC6-D09ED2EF09BB}"/>
              </a:ext>
            </a:extLst>
          </p:cNvPr>
          <p:cNvSpPr txBox="1"/>
          <p:nvPr/>
        </p:nvSpPr>
        <p:spPr>
          <a:xfrm rot="16200000">
            <a:off x="6776518" y="5164037"/>
            <a:ext cx="10184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AABBD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907AB1A-2CD0-BBE6-37D0-04473AC4581E}"/>
              </a:ext>
            </a:extLst>
          </p:cNvPr>
          <p:cNvSpPr txBox="1"/>
          <p:nvPr/>
        </p:nvSpPr>
        <p:spPr>
          <a:xfrm rot="16200000">
            <a:off x="1989603" y="4057360"/>
            <a:ext cx="10184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AABBD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B6E62A7-945F-D029-908C-639CDCB2BF6E}"/>
              </a:ext>
            </a:extLst>
          </p:cNvPr>
          <p:cNvSpPr txBox="1"/>
          <p:nvPr/>
        </p:nvSpPr>
        <p:spPr>
          <a:xfrm rot="16200000">
            <a:off x="754261" y="889414"/>
            <a:ext cx="6155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8871A2D-FE97-6643-7C56-E0E6171574E1}"/>
              </a:ext>
            </a:extLst>
          </p:cNvPr>
          <p:cNvSpPr txBox="1"/>
          <p:nvPr/>
        </p:nvSpPr>
        <p:spPr>
          <a:xfrm rot="16200000">
            <a:off x="6930925" y="1985665"/>
            <a:ext cx="6477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DD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9AA9FFB-38C0-DA30-AB7B-3E57D45C168D}"/>
              </a:ext>
            </a:extLst>
          </p:cNvPr>
          <p:cNvSpPr txBox="1"/>
          <p:nvPr/>
        </p:nvSpPr>
        <p:spPr>
          <a:xfrm rot="16200000">
            <a:off x="2076452" y="1966921"/>
            <a:ext cx="844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AAB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7D82AEE-29BA-DBBF-2642-BFFDA748CF09}"/>
              </a:ext>
            </a:extLst>
          </p:cNvPr>
          <p:cNvSpPr txBox="1"/>
          <p:nvPr/>
        </p:nvSpPr>
        <p:spPr>
          <a:xfrm rot="16200000">
            <a:off x="4514858" y="3005146"/>
            <a:ext cx="8447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AABB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C33C5F7-C222-C134-1067-E60247F72A35}"/>
              </a:ext>
            </a:extLst>
          </p:cNvPr>
          <p:cNvSpPr txBox="1"/>
          <p:nvPr/>
        </p:nvSpPr>
        <p:spPr>
          <a:xfrm rot="16200000">
            <a:off x="5621535" y="889414"/>
            <a:ext cx="6155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BB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471BCAC8-8E04-4C2E-C881-7B45CCC8F340}"/>
              </a:ext>
            </a:extLst>
          </p:cNvPr>
          <p:cNvCxnSpPr>
            <a:cxnSpLocks/>
          </p:cNvCxnSpPr>
          <p:nvPr/>
        </p:nvCxnSpPr>
        <p:spPr>
          <a:xfrm>
            <a:off x="2943225" y="1543662"/>
            <a:ext cx="0" cy="309562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C2FEDB06-B51D-77AC-C57C-9FCDED5849EE}"/>
              </a:ext>
            </a:extLst>
          </p:cNvPr>
          <p:cNvCxnSpPr>
            <a:cxnSpLocks/>
          </p:cNvCxnSpPr>
          <p:nvPr/>
        </p:nvCxnSpPr>
        <p:spPr>
          <a:xfrm>
            <a:off x="4219575" y="1543662"/>
            <a:ext cx="0" cy="309562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35822C6D-783D-C76B-0106-CBE6EAE07427}"/>
              </a:ext>
            </a:extLst>
          </p:cNvPr>
          <p:cNvCxnSpPr>
            <a:cxnSpLocks/>
          </p:cNvCxnSpPr>
          <p:nvPr/>
        </p:nvCxnSpPr>
        <p:spPr>
          <a:xfrm>
            <a:off x="3582619" y="2581888"/>
            <a:ext cx="0" cy="309562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541085A1-49D7-45BF-9EB0-49135F23F18E}"/>
              </a:ext>
            </a:extLst>
          </p:cNvPr>
          <p:cNvCxnSpPr>
            <a:cxnSpLocks/>
          </p:cNvCxnSpPr>
          <p:nvPr/>
        </p:nvCxnSpPr>
        <p:spPr>
          <a:xfrm>
            <a:off x="3582619" y="3649469"/>
            <a:ext cx="0" cy="309562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9F4D2E3C-B1FA-A660-3504-3D35C2D098C5}"/>
              </a:ext>
            </a:extLst>
          </p:cNvPr>
          <p:cNvCxnSpPr>
            <a:cxnSpLocks/>
          </p:cNvCxnSpPr>
          <p:nvPr/>
        </p:nvCxnSpPr>
        <p:spPr>
          <a:xfrm>
            <a:off x="6324600" y="2633663"/>
            <a:ext cx="0" cy="2262187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ED594DCE-DD3C-F86A-C00A-B57DFAA9F9F8}"/>
              </a:ext>
            </a:extLst>
          </p:cNvPr>
          <p:cNvCxnSpPr>
            <a:cxnSpLocks/>
          </p:cNvCxnSpPr>
          <p:nvPr/>
        </p:nvCxnSpPr>
        <p:spPr>
          <a:xfrm>
            <a:off x="5775423" y="4211248"/>
            <a:ext cx="0" cy="684602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089F9AB6-3C27-A2E1-426E-CEB41CF9B734}"/>
              </a:ext>
            </a:extLst>
          </p:cNvPr>
          <p:cNvCxnSpPr>
            <a:cxnSpLocks/>
          </p:cNvCxnSpPr>
          <p:nvPr/>
        </p:nvCxnSpPr>
        <p:spPr>
          <a:xfrm>
            <a:off x="4676770" y="3599259"/>
            <a:ext cx="1098653" cy="629848"/>
          </a:xfrm>
          <a:prstGeom prst="line">
            <a:avLst/>
          </a:prstGeom>
          <a:ln w="4762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1A429820-DD55-8412-4BED-449638BAD362}"/>
              </a:ext>
            </a:extLst>
          </p:cNvPr>
          <p:cNvCxnSpPr>
            <a:cxnSpLocks/>
          </p:cNvCxnSpPr>
          <p:nvPr/>
        </p:nvCxnSpPr>
        <p:spPr>
          <a:xfrm>
            <a:off x="5695948" y="2664009"/>
            <a:ext cx="0" cy="773620"/>
          </a:xfrm>
          <a:prstGeom prst="line">
            <a:avLst/>
          </a:prstGeom>
          <a:ln w="4762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9AFDA68C-AABC-83E2-B660-29E34021BD74}"/>
              </a:ext>
            </a:extLst>
          </p:cNvPr>
          <p:cNvCxnSpPr>
            <a:cxnSpLocks/>
          </p:cNvCxnSpPr>
          <p:nvPr/>
        </p:nvCxnSpPr>
        <p:spPr>
          <a:xfrm flipH="1">
            <a:off x="4783335" y="3419575"/>
            <a:ext cx="912613" cy="773619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FFED6E3C-85BD-DEFC-5CCF-5593DE981DEF}"/>
              </a:ext>
            </a:extLst>
          </p:cNvPr>
          <p:cNvCxnSpPr>
            <a:cxnSpLocks/>
          </p:cNvCxnSpPr>
          <p:nvPr/>
        </p:nvCxnSpPr>
        <p:spPr>
          <a:xfrm flipH="1">
            <a:off x="2076594" y="3229856"/>
            <a:ext cx="536667" cy="0"/>
          </a:xfrm>
          <a:prstGeom prst="line">
            <a:avLst/>
          </a:prstGeom>
          <a:ln w="4762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786234FD-DA58-3F39-723A-4864B41813F9}"/>
              </a:ext>
            </a:extLst>
          </p:cNvPr>
          <p:cNvCxnSpPr>
            <a:cxnSpLocks/>
          </p:cNvCxnSpPr>
          <p:nvPr/>
        </p:nvCxnSpPr>
        <p:spPr>
          <a:xfrm>
            <a:off x="2076594" y="3209653"/>
            <a:ext cx="0" cy="1679373"/>
          </a:xfrm>
          <a:prstGeom prst="straightConnector1">
            <a:avLst/>
          </a:prstGeom>
          <a:ln w="47625" cmpd="sng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E6313152-B568-ECBE-3509-7B4150ED5255}"/>
              </a:ext>
            </a:extLst>
          </p:cNvPr>
          <p:cNvSpPr txBox="1"/>
          <p:nvPr/>
        </p:nvSpPr>
        <p:spPr>
          <a:xfrm>
            <a:off x="8810625" y="590550"/>
            <a:ext cx="15940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400" dirty="0">
                <a:latin typeface="Arial" panose="020B0604020202020204" pitchFamily="34" charset="0"/>
                <a:cs typeface="Arial" panose="020B0604020202020204" pitchFamily="34" charset="0"/>
              </a:rPr>
              <a:t>Suppl Fig 1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F6954E3-71C4-5AFA-8EDF-B60943692E12}"/>
              </a:ext>
            </a:extLst>
          </p:cNvPr>
          <p:cNvSpPr txBox="1"/>
          <p:nvPr/>
        </p:nvSpPr>
        <p:spPr>
          <a:xfrm>
            <a:off x="1600200" y="6234615"/>
            <a:ext cx="5808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Arial" panose="020B0604020202020204" pitchFamily="34" charset="0"/>
                <a:cs typeface="Arial" panose="020B0604020202020204" pitchFamily="34" charset="0"/>
              </a:rPr>
              <a:t>Figure 1. Evolution of wheat. Based on da Silva et al (2014) </a:t>
            </a:r>
          </a:p>
        </p:txBody>
      </p:sp>
    </p:spTree>
    <p:extLst>
      <p:ext uri="{BB962C8B-B14F-4D97-AF65-F5344CB8AC3E}">
        <p14:creationId xmlns:p14="http://schemas.microsoft.com/office/powerpoint/2010/main" val="739812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60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Shabala</dc:creator>
  <cp:lastModifiedBy>Sergey Shabala</cp:lastModifiedBy>
  <cp:revision>9</cp:revision>
  <dcterms:created xsi:type="dcterms:W3CDTF">2024-11-19T06:48:23Z</dcterms:created>
  <dcterms:modified xsi:type="dcterms:W3CDTF">2025-04-01T09:43:14Z</dcterms:modified>
</cp:coreProperties>
</file>